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42"/>
    <p:restoredTop sz="94692"/>
  </p:normalViewPr>
  <p:slideViewPr>
    <p:cSldViewPr snapToGrid="0" snapToObjects="1">
      <p:cViewPr varScale="1">
        <p:scale>
          <a:sx n="189" d="100"/>
          <a:sy n="189" d="100"/>
        </p:scale>
        <p:origin x="102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A9986-664C-AD45-B664-FB6E5DF8D3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27BECB-199B-4E49-AFE5-0E0C0986BC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40FC0F-54C3-9D4F-A21B-0028AA622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CD11C6-5996-7A41-96E6-5E1DE4CF8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96E1CB-3D50-1941-9D41-40A56ED5D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392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EA822-59AB-DC47-A89E-74A0D1B15E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8CA4C-25FF-9F4F-A143-B07CBAA096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E1F710-D68A-3A45-9D9C-A50E705B1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3ADC6-2123-7C4C-A17C-C9F27C7E2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B903B3-F3F7-0541-89AC-9465277FB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85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85A00A-DC36-AF43-BBE2-D83CDB65B3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2C47BF-C690-6448-B210-FC6512A05E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6E8A8E-15EB-594E-8845-741F922DE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92723-7A9A-3D40-A017-FBC684E48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E05C53-05F3-364D-BAA2-81D0621FD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51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CA330D-0E21-8B45-87B4-D652AB2272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224FC7-D745-5B40-BCB8-B90AE7E813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377317-B35C-7847-A8F3-2F2CFA9A4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4A4B0-BCF9-1B49-A04C-572447999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3A07CB-CA2A-544A-B5A2-115E15221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26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D2968-492A-4946-847B-8A1E44919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53822E-7F92-724E-873B-3E0A317906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FDA3D5-77EF-B840-AFA6-FAD3272C6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52021-F8CC-0F44-BF51-F453AB7B7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7C3CF1-87EC-C042-AB68-C373A0BA7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825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84C27-7F3F-5349-9FE0-9E0303BDA0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EEC2C6-9CD1-4A43-BC07-DE3D33C755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847AC5-0CF8-6E40-ACDF-4F6AB05ED2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B2844C-899C-F04B-B963-E64B6230A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C2167B-85F9-344D-A123-9265784A6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5F4FBC-D7B8-B24C-B5AC-50BBBC2F1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710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971A9-EDB4-F145-AAE9-300805F6E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77727-5BB1-DF4C-A5E7-B94834C25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F68039-90D4-2949-95C0-9F9F117971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295682-0FF5-1C4B-A413-1552923054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06F244-5795-CD45-8C52-A3E9B11BF7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45A63C-F5A4-1340-BB6A-15415AD1C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D9DE57-BC4B-2949-A100-FDD7822DA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F2CDD0-8F43-954C-BA4E-E74866A05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686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5C5B4F-B959-F349-994D-8F060433A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9378BF-9713-9840-85CE-5C8C611DD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25E848-FBCF-2B4A-8E05-5CDA55A84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BF292F-DD47-2240-9F7A-7BCEA6337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290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5A25F4-B704-0E46-8022-8AA27EADF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895033-3A66-CB4E-8122-93D6C7F57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6F6541-88A1-CF49-B788-B2E03D555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364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174508-F97B-4840-8AC8-CA10FB5A23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0ED3E4-0759-AB4F-BC05-91E42C99C5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05266C-A9CC-8E48-9BF4-38895A16F0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B7EECC-D6C6-4A48-9EAF-2992B3027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82C751-5C93-4B46-BB23-272CBE6147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1EDFB4-91A6-E944-9778-14433F966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348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22867-15C1-324E-BD26-F7D8371DB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E1F136-5331-2F44-986B-84CBFEEE19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82BA59-56F8-BD4C-B258-B1A6672A69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BF8E3C-C40F-954A-880F-94938C761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8A9532-AC39-B84B-859A-D34509CA5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9A8496-FA1E-9E47-A7ED-BF77F69C1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971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5D071FA-F098-1A4D-899B-9C5866E85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0DCB80-E0BE-AB40-9E3D-63DD36E8C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2B723A-7C24-7541-AF11-C064AAF825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6AEB2C-D6AF-7941-9E61-56404980679B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AACB27-ED38-E14F-9307-2B7394290A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A8EEA4-1AFF-C84A-AAFF-5D3F86164C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E1B31-DED8-D844-AE2D-C0235B085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021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9973546-B60E-884D-98E3-DEE9885F2A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161" y="406539"/>
            <a:ext cx="5291666" cy="3721794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BF8BBDED-1E5C-0047-87C8-0F497EC709AB}"/>
              </a:ext>
            </a:extLst>
          </p:cNvPr>
          <p:cNvCxnSpPr>
            <a:cxnSpLocks/>
          </p:cNvCxnSpPr>
          <p:nvPr/>
        </p:nvCxnSpPr>
        <p:spPr>
          <a:xfrm flipV="1">
            <a:off x="2952683" y="2519749"/>
            <a:ext cx="2875770" cy="12517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B1270DD-77D2-FD4B-9087-1035C3B00783}"/>
              </a:ext>
            </a:extLst>
          </p:cNvPr>
          <p:cNvCxnSpPr>
            <a:cxnSpLocks/>
          </p:cNvCxnSpPr>
          <p:nvPr/>
        </p:nvCxnSpPr>
        <p:spPr>
          <a:xfrm flipV="1">
            <a:off x="2658516" y="3514387"/>
            <a:ext cx="3169937" cy="113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D2213C4-B549-F14B-9D20-03B27241AFCB}"/>
              </a:ext>
            </a:extLst>
          </p:cNvPr>
          <p:cNvCxnSpPr>
            <a:cxnSpLocks/>
          </p:cNvCxnSpPr>
          <p:nvPr/>
        </p:nvCxnSpPr>
        <p:spPr>
          <a:xfrm flipV="1">
            <a:off x="3033496" y="3190034"/>
            <a:ext cx="2794957" cy="7512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5F68FDB-B3DD-294C-9B01-FFE1AFE9C43A}"/>
              </a:ext>
            </a:extLst>
          </p:cNvPr>
          <p:cNvCxnSpPr>
            <a:cxnSpLocks/>
          </p:cNvCxnSpPr>
          <p:nvPr/>
        </p:nvCxnSpPr>
        <p:spPr>
          <a:xfrm flipV="1">
            <a:off x="2615988" y="495279"/>
            <a:ext cx="1844749" cy="80907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D5903E8-FE3F-C745-86ED-2E4875DA513C}"/>
              </a:ext>
            </a:extLst>
          </p:cNvPr>
          <p:cNvCxnSpPr>
            <a:cxnSpLocks/>
          </p:cNvCxnSpPr>
          <p:nvPr/>
        </p:nvCxnSpPr>
        <p:spPr>
          <a:xfrm flipV="1">
            <a:off x="4253399" y="950807"/>
            <a:ext cx="597731" cy="264812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BCDAD82-6E1F-5441-85F9-94C8ECDEF4D7}"/>
              </a:ext>
            </a:extLst>
          </p:cNvPr>
          <p:cNvCxnSpPr>
            <a:cxnSpLocks/>
          </p:cNvCxnSpPr>
          <p:nvPr/>
        </p:nvCxnSpPr>
        <p:spPr>
          <a:xfrm flipV="1">
            <a:off x="4212993" y="1525734"/>
            <a:ext cx="1022146" cy="44890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>
            <a:extLst>
              <a:ext uri="{FF2B5EF4-FFF2-40B4-BE49-F238E27FC236}">
                <a16:creationId xmlns:a16="http://schemas.microsoft.com/office/drawing/2014/main" id="{4C8D70EF-5B58-0548-B3DD-64D0130DC5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814641"/>
            <a:ext cx="6315084" cy="4043359"/>
          </a:xfrm>
          <a:prstGeom prst="rect">
            <a:avLst/>
          </a:prstGeom>
        </p:spPr>
      </p:pic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5FB5ABA-1D33-8043-8D08-27BF8BD2530F}"/>
              </a:ext>
            </a:extLst>
          </p:cNvPr>
          <p:cNvCxnSpPr>
            <a:cxnSpLocks/>
          </p:cNvCxnSpPr>
          <p:nvPr/>
        </p:nvCxnSpPr>
        <p:spPr>
          <a:xfrm>
            <a:off x="5351721" y="4900390"/>
            <a:ext cx="317385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885AD0B5-4044-904D-93FD-E9BEBA33216A}"/>
              </a:ext>
            </a:extLst>
          </p:cNvPr>
          <p:cNvCxnSpPr>
            <a:cxnSpLocks/>
          </p:cNvCxnSpPr>
          <p:nvPr/>
        </p:nvCxnSpPr>
        <p:spPr>
          <a:xfrm>
            <a:off x="5235139" y="4280158"/>
            <a:ext cx="2016656" cy="1461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B0049CD-F3F8-9E49-B870-0CA118C84C29}"/>
              </a:ext>
            </a:extLst>
          </p:cNvPr>
          <p:cNvSpPr txBox="1"/>
          <p:nvPr/>
        </p:nvSpPr>
        <p:spPr>
          <a:xfrm>
            <a:off x="4463315" y="356566"/>
            <a:ext cx="1203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ir inle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7E6983C-ADED-7146-8353-99CAE4CDBABD}"/>
              </a:ext>
            </a:extLst>
          </p:cNvPr>
          <p:cNvSpPr txBox="1"/>
          <p:nvPr/>
        </p:nvSpPr>
        <p:spPr>
          <a:xfrm>
            <a:off x="4851130" y="797873"/>
            <a:ext cx="21144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utout to allow top glass remova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0205FB-DCDB-B14E-BEB9-4D1FBBB4539A}"/>
              </a:ext>
            </a:extLst>
          </p:cNvPr>
          <p:cNvSpPr txBox="1"/>
          <p:nvPr/>
        </p:nvSpPr>
        <p:spPr>
          <a:xfrm>
            <a:off x="5279658" y="1380490"/>
            <a:ext cx="2553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ort ridge for perforated plat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E18211D-C829-4247-8B82-DE6C6FBE3BD2}"/>
              </a:ext>
            </a:extLst>
          </p:cNvPr>
          <p:cNvSpPr txBox="1"/>
          <p:nvPr/>
        </p:nvSpPr>
        <p:spPr>
          <a:xfrm>
            <a:off x="5867686" y="2366666"/>
            <a:ext cx="12035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idge to position suppor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B891C3D-4258-5045-8DAB-35ED66DB9151}"/>
              </a:ext>
            </a:extLst>
          </p:cNvPr>
          <p:cNvSpPr txBox="1"/>
          <p:nvPr/>
        </p:nvSpPr>
        <p:spPr>
          <a:xfrm>
            <a:off x="5881414" y="3051534"/>
            <a:ext cx="2605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utouts to hold elastic bands in plac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96B29DB-79C9-0245-9A02-91874C6B9906}"/>
              </a:ext>
            </a:extLst>
          </p:cNvPr>
          <p:cNvSpPr txBox="1"/>
          <p:nvPr/>
        </p:nvSpPr>
        <p:spPr>
          <a:xfrm>
            <a:off x="5828453" y="3406079"/>
            <a:ext cx="12035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ir out to senso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AE8CD0-3B80-2045-B25B-49D1E09A8B1D}"/>
              </a:ext>
            </a:extLst>
          </p:cNvPr>
          <p:cNvSpPr txBox="1"/>
          <p:nvPr/>
        </p:nvSpPr>
        <p:spPr>
          <a:xfrm>
            <a:off x="2774128" y="4146727"/>
            <a:ext cx="24610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idge for fixing seal strip and holding glass plate in place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ED93891-0B66-C049-BCEB-132357D71F77}"/>
              </a:ext>
            </a:extLst>
          </p:cNvPr>
          <p:cNvSpPr txBox="1"/>
          <p:nvPr/>
        </p:nvSpPr>
        <p:spPr>
          <a:xfrm>
            <a:off x="4031627" y="4772700"/>
            <a:ext cx="1203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erforated plate</a:t>
            </a:r>
          </a:p>
        </p:txBody>
      </p:sp>
    </p:spTree>
    <p:extLst>
      <p:ext uri="{BB962C8B-B14F-4D97-AF65-F5344CB8AC3E}">
        <p14:creationId xmlns:p14="http://schemas.microsoft.com/office/powerpoint/2010/main" val="2535654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1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Atkinson</dc:creator>
  <cp:lastModifiedBy>Jonathan Atkinson</cp:lastModifiedBy>
  <cp:revision>3</cp:revision>
  <dcterms:created xsi:type="dcterms:W3CDTF">2019-03-21T12:39:10Z</dcterms:created>
  <dcterms:modified xsi:type="dcterms:W3CDTF">2019-03-26T14:51:46Z</dcterms:modified>
</cp:coreProperties>
</file>